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4660"/>
  </p:normalViewPr>
  <p:slideViewPr>
    <p:cSldViewPr snapToGrid="0">
      <p:cViewPr varScale="1">
        <p:scale>
          <a:sx n="60" d="100"/>
          <a:sy n="60" d="100"/>
        </p:scale>
        <p:origin x="52" y="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F4EF2-69BF-6CC7-4AC9-313A00F94F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A133E2-20FB-9BCD-0283-20B69B808E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89BFDE-9720-DFB1-6709-CC4433E43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E66864-AE9A-354B-E957-6E46B8AB4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C571EC-537B-5222-07DB-184FC9725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C709F-5D1A-96F0-C870-AB8B6C38C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9148A9-D45A-61CC-125C-C73E890A1F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CC4FF-CCD1-1699-F3DB-F3AEE2C67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799E4B-36C4-6E0E-765D-432EB0B11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72ACC9-C40C-CB42-10E9-34BE4274A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528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AB9A48-774B-F267-0575-F96A13E6E7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2B1221-9AD7-A9AE-518C-E12BF5678C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11D7F9-147E-0C67-9D21-0A34CF537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F04FC3-994F-C254-DA31-34C5EE46D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0450F-4515-A4F7-98AA-CEB6F21D3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397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BD623-16A0-002E-ED4F-18014F6D3D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EA7459-0CCF-0D9E-F1E2-650ED2D5BB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761CA1-9982-9CB2-AFFE-691489D59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2652F4-F09B-90D8-E60E-2FEF2B9D7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428859-93F6-A0C4-CE17-8FD516007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99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3AABB-7ED5-3BF0-272C-FB9477998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FA7E0D-3591-450E-EE02-DF5514247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DBF0E-F05D-D63D-07BA-D92906CED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2D40C0-6135-C7DB-B58E-677B03917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AFDC96-2379-8806-BB44-065A9B9EB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00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DB748-FF95-077A-6061-430C00200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BEB812-3AC4-86C2-A583-1A711CD632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CB0BE4-60B4-1F85-573F-4D3D87E9FC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19F06F-216C-1D55-E21A-E9E12FAC0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EF2C9B-085B-4923-1E16-D7425BFE0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6D9D7A-5E96-04A9-8C57-35198F623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37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F038D-B57F-5FBE-92FE-1B46602FC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9DF2B5-3DA4-723C-04C9-E01CE5F4FD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67F368-454F-5AD0-672E-5A17506D7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45F918-CEC8-F9D5-1BB6-5BA4434953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4D1C1E4-9228-AB65-2DE5-0F33FDC39D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388AEE-02D4-B597-E617-903E5F96E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07D2B5-B5FD-28D2-20B0-D5A5C41F9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996A47-2B5A-2D79-5058-739B8591B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227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688A8-6AC0-8D5D-1E0D-CC6C2B39A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D76C8C-C84A-02A6-B398-2A68507D7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82AF6E-B48C-9D77-0F41-2A3E0C4FC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764658-B073-093D-C13C-73EC91E08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129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19BBB7-8245-43BB-3FCD-C063B5B0A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C8410B-C296-44A9-A31E-E36DCFE9D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F5AADE-B873-A102-636B-1F4443F45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652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F419C-C6F4-4DCF-6F3A-62A2F56CF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2EE25-0C58-FFF8-8EA5-F5A3B13C85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B90F6D-F1F8-8E8E-ABFA-E8B115249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146AB4-9EEE-547C-D5C0-5C6DF8615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197F98-BCA8-5A77-457B-1758A2528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F24C0A-6291-5EC6-857D-774ECEFC3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811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B05A74-D6AC-5C3D-1A13-43CC494F2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3E8982-4234-3959-7780-C334CB61FB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8EE99B-91F9-5825-0A5E-4E2794492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002F3D-881E-9ED2-D523-5741A6525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FB6D0A-8355-C8FF-B00E-972A23C83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DFFE13-FF91-6E2E-EA4E-5C9E9FBDA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633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E908B0-CD3A-4A85-2031-4066D3587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47EFEC-26EF-D1A5-AE3D-F66AE27118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EFD28-3586-2429-CF9E-4A2D342EA0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84A05B-A4BF-4C3C-9E90-F389EE343277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8BCEB9-A465-7B6E-5093-5970473F70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9FDDDD-335A-922A-A143-C6D911B1D3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F366E0-CDAD-4A62-8D5D-E7576AF0C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962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433;g2c703f76459_0_78">
            <a:extLst>
              <a:ext uri="{FF2B5EF4-FFF2-40B4-BE49-F238E27FC236}">
                <a16:creationId xmlns:a16="http://schemas.microsoft.com/office/drawing/2014/main" id="{7AC0ED6E-926D-4C2D-B4A3-DC61F5CA665B}"/>
              </a:ext>
            </a:extLst>
          </p:cNvPr>
          <p:cNvSpPr txBox="1"/>
          <p:nvPr/>
        </p:nvSpPr>
        <p:spPr>
          <a:xfrm>
            <a:off x="1551797" y="893728"/>
            <a:ext cx="7027875" cy="3462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b="1" dirty="0">
                <a:solidFill>
                  <a:srgbClr val="382A2A"/>
                </a:solidFill>
                <a:latin typeface="Arial" panose="020B0604020202020204" pitchFamily="34" charset="0"/>
                <a:ea typeface="Century Gothic"/>
                <a:cs typeface="Arial" panose="020B0604020202020204" pitchFamily="34" charset="0"/>
                <a:sym typeface="Century Gothic"/>
              </a:rPr>
              <a:t>Suppl. Fig. 3</a:t>
            </a:r>
            <a:endParaRPr b="1" dirty="0">
              <a:solidFill>
                <a:srgbClr val="382A2A"/>
              </a:solidFill>
              <a:latin typeface="Arial" panose="020B0604020202020204" pitchFamily="34" charset="0"/>
              <a:ea typeface="Century Gothic"/>
              <a:cs typeface="Arial" panose="020B0604020202020204" pitchFamily="34" charset="0"/>
              <a:sym typeface="Century Gothic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7BC2152-796A-4016-9FAC-AF722A1F8620}"/>
              </a:ext>
            </a:extLst>
          </p:cNvPr>
          <p:cNvSpPr txBox="1"/>
          <p:nvPr/>
        </p:nvSpPr>
        <p:spPr>
          <a:xfrm>
            <a:off x="3612328" y="1101961"/>
            <a:ext cx="3751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trocytes in the aging brain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97A7672-3AC5-42E8-97BB-53CCE93B3221}"/>
              </a:ext>
            </a:extLst>
          </p:cNvPr>
          <p:cNvGrpSpPr/>
          <p:nvPr/>
        </p:nvGrpSpPr>
        <p:grpSpPr>
          <a:xfrm>
            <a:off x="1991899" y="1454563"/>
            <a:ext cx="3540566" cy="2211683"/>
            <a:chOff x="95541" y="810762"/>
            <a:chExt cx="4720755" cy="2948911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9BCD4E5-A21B-4D27-AE82-DBD625C23DDF}"/>
                </a:ext>
              </a:extLst>
            </p:cNvPr>
            <p:cNvSpPr txBox="1"/>
            <p:nvPr/>
          </p:nvSpPr>
          <p:spPr>
            <a:xfrm>
              <a:off x="268465" y="3451897"/>
              <a:ext cx="454783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enescence core genes enrichment score </a:t>
              </a:r>
            </a:p>
          </p:txBody>
        </p:sp>
        <p:pic>
          <p:nvPicPr>
            <p:cNvPr id="13" name="Kép 1">
              <a:extLst>
                <a:ext uri="{FF2B5EF4-FFF2-40B4-BE49-F238E27FC236}">
                  <a16:creationId xmlns:a16="http://schemas.microsoft.com/office/drawing/2014/main" id="{6B3CC168-1C1D-48C7-ABF8-955482D95E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30" r="15432" b="10074"/>
            <a:stretch/>
          </p:blipFill>
          <p:spPr>
            <a:xfrm>
              <a:off x="576349" y="810762"/>
              <a:ext cx="4136702" cy="2505272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B03F0C4-86B9-4705-8A43-9775B3107B7E}"/>
                </a:ext>
              </a:extLst>
            </p:cNvPr>
            <p:cNvSpPr txBox="1"/>
            <p:nvPr/>
          </p:nvSpPr>
          <p:spPr>
            <a:xfrm rot="16200000">
              <a:off x="-659545" y="2017578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AF55D30-4C6E-41CC-811D-6DB461F722DA}"/>
                </a:ext>
              </a:extLst>
            </p:cNvPr>
            <p:cNvSpPr txBox="1"/>
            <p:nvPr/>
          </p:nvSpPr>
          <p:spPr>
            <a:xfrm>
              <a:off x="387926" y="3040436"/>
              <a:ext cx="18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6627963-3C19-4EC7-84E9-5A2C507CC8DF}"/>
                </a:ext>
              </a:extLst>
            </p:cNvPr>
            <p:cNvSpPr txBox="1"/>
            <p:nvPr/>
          </p:nvSpPr>
          <p:spPr>
            <a:xfrm>
              <a:off x="320930" y="2361564"/>
              <a:ext cx="3713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133F39D-39B4-470C-AF2C-72A68A636C23}"/>
                </a:ext>
              </a:extLst>
            </p:cNvPr>
            <p:cNvSpPr txBox="1"/>
            <p:nvPr/>
          </p:nvSpPr>
          <p:spPr>
            <a:xfrm>
              <a:off x="320930" y="1682691"/>
              <a:ext cx="3713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136D4F3-BAFF-4CD4-8B3C-F486AE378079}"/>
                </a:ext>
              </a:extLst>
            </p:cNvPr>
            <p:cNvSpPr txBox="1"/>
            <p:nvPr/>
          </p:nvSpPr>
          <p:spPr>
            <a:xfrm>
              <a:off x="330957" y="1016271"/>
              <a:ext cx="3713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D706E8E-EAC8-47C6-A0DD-4805A9802BC2}"/>
                </a:ext>
              </a:extLst>
            </p:cNvPr>
            <p:cNvSpPr txBox="1"/>
            <p:nvPr/>
          </p:nvSpPr>
          <p:spPr>
            <a:xfrm>
              <a:off x="670558" y="3258713"/>
              <a:ext cx="18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994EF3D-7369-46EF-B634-8CA11525B52F}"/>
                </a:ext>
              </a:extLst>
            </p:cNvPr>
            <p:cNvSpPr txBox="1"/>
            <p:nvPr/>
          </p:nvSpPr>
          <p:spPr>
            <a:xfrm>
              <a:off x="1418705" y="3258713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267C73E-D72E-470C-B975-C756D6B5503C}"/>
                </a:ext>
              </a:extLst>
            </p:cNvPr>
            <p:cNvSpPr txBox="1"/>
            <p:nvPr/>
          </p:nvSpPr>
          <p:spPr>
            <a:xfrm>
              <a:off x="2303272" y="3252776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D65CAAE-791B-42C3-8989-F7AD552D1C5E}"/>
                </a:ext>
              </a:extLst>
            </p:cNvPr>
            <p:cNvSpPr txBox="1"/>
            <p:nvPr/>
          </p:nvSpPr>
          <p:spPr>
            <a:xfrm>
              <a:off x="3145897" y="3258712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92B8284-F895-406D-9FBC-1DFDECAFCCA6}"/>
                </a:ext>
              </a:extLst>
            </p:cNvPr>
            <p:cNvSpPr txBox="1"/>
            <p:nvPr/>
          </p:nvSpPr>
          <p:spPr>
            <a:xfrm>
              <a:off x="4030464" y="3246840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632D6970-3C1F-4131-B46C-90CD320CC911}"/>
              </a:ext>
            </a:extLst>
          </p:cNvPr>
          <p:cNvGrpSpPr/>
          <p:nvPr/>
        </p:nvGrpSpPr>
        <p:grpSpPr>
          <a:xfrm>
            <a:off x="5793288" y="1463749"/>
            <a:ext cx="3670251" cy="2229200"/>
            <a:chOff x="5692384" y="808665"/>
            <a:chExt cx="4893668" cy="2972267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36F924A-1C39-48A9-9C93-639C048AE16A}"/>
                </a:ext>
              </a:extLst>
            </p:cNvPr>
            <p:cNvSpPr txBox="1"/>
            <p:nvPr/>
          </p:nvSpPr>
          <p:spPr>
            <a:xfrm>
              <a:off x="6147866" y="3473156"/>
              <a:ext cx="4438186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ASP genes enrichment score </a:t>
              </a:r>
            </a:p>
          </p:txBody>
        </p:sp>
        <p:pic>
          <p:nvPicPr>
            <p:cNvPr id="14" name="Kép 6">
              <a:extLst>
                <a:ext uri="{FF2B5EF4-FFF2-40B4-BE49-F238E27FC236}">
                  <a16:creationId xmlns:a16="http://schemas.microsoft.com/office/drawing/2014/main" id="{21D7A3FB-B885-40B0-AFBE-683B48E691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476" r="16203" b="10073"/>
            <a:stretch/>
          </p:blipFill>
          <p:spPr>
            <a:xfrm>
              <a:off x="6235604" y="817369"/>
              <a:ext cx="4099187" cy="2505273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100C858-5330-4965-B907-61808FECE5E2}"/>
                </a:ext>
              </a:extLst>
            </p:cNvPr>
            <p:cNvSpPr txBox="1"/>
            <p:nvPr/>
          </p:nvSpPr>
          <p:spPr>
            <a:xfrm>
              <a:off x="7406316" y="3263016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482B20F-CB53-42B7-8DBD-435D1A3588B5}"/>
                </a:ext>
              </a:extLst>
            </p:cNvPr>
            <p:cNvSpPr txBox="1"/>
            <p:nvPr/>
          </p:nvSpPr>
          <p:spPr>
            <a:xfrm>
              <a:off x="6336287" y="3264963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5CC0E7C-F52B-4E48-9D0D-0805B5E1821E}"/>
                </a:ext>
              </a:extLst>
            </p:cNvPr>
            <p:cNvSpPr txBox="1"/>
            <p:nvPr/>
          </p:nvSpPr>
          <p:spPr>
            <a:xfrm>
              <a:off x="8621969" y="3255729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8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7DC558A-D131-4F8C-93B5-5698AF6AD8A2}"/>
                </a:ext>
              </a:extLst>
            </p:cNvPr>
            <p:cNvSpPr txBox="1"/>
            <p:nvPr/>
          </p:nvSpPr>
          <p:spPr>
            <a:xfrm>
              <a:off x="9788263" y="3255729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AC04E40-68AF-46A5-ADEF-60579CA82667}"/>
                </a:ext>
              </a:extLst>
            </p:cNvPr>
            <p:cNvSpPr txBox="1"/>
            <p:nvPr/>
          </p:nvSpPr>
          <p:spPr>
            <a:xfrm>
              <a:off x="6063131" y="3055895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8FE60BD-17A2-4533-8756-830A08549BEB}"/>
                </a:ext>
              </a:extLst>
            </p:cNvPr>
            <p:cNvSpPr txBox="1"/>
            <p:nvPr/>
          </p:nvSpPr>
          <p:spPr>
            <a:xfrm>
              <a:off x="6053655" y="2484675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63A0DE4-61C3-4900-938F-D0B862F86A1F}"/>
                </a:ext>
              </a:extLst>
            </p:cNvPr>
            <p:cNvSpPr txBox="1"/>
            <p:nvPr/>
          </p:nvSpPr>
          <p:spPr>
            <a:xfrm>
              <a:off x="5980322" y="1928913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4D99EE7-4836-4C90-9E5B-66D8C1D8D14C}"/>
                </a:ext>
              </a:extLst>
            </p:cNvPr>
            <p:cNvSpPr txBox="1"/>
            <p:nvPr/>
          </p:nvSpPr>
          <p:spPr>
            <a:xfrm>
              <a:off x="5980322" y="1372156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89A8A38-D9F7-4512-8E83-A8E60284D773}"/>
                </a:ext>
              </a:extLst>
            </p:cNvPr>
            <p:cNvSpPr txBox="1"/>
            <p:nvPr/>
          </p:nvSpPr>
          <p:spPr>
            <a:xfrm>
              <a:off x="5980322" y="808665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36B8906-266B-4542-B7B5-25122542FF85}"/>
                </a:ext>
              </a:extLst>
            </p:cNvPr>
            <p:cNvSpPr txBox="1"/>
            <p:nvPr/>
          </p:nvSpPr>
          <p:spPr>
            <a:xfrm rot="16200000">
              <a:off x="4937298" y="1894466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5A2A2790-7D54-4E17-9E83-680A2D27A586}"/>
              </a:ext>
            </a:extLst>
          </p:cNvPr>
          <p:cNvGrpSpPr/>
          <p:nvPr/>
        </p:nvGrpSpPr>
        <p:grpSpPr>
          <a:xfrm>
            <a:off x="3765043" y="3793163"/>
            <a:ext cx="3718656" cy="2219077"/>
            <a:chOff x="2988058" y="3914550"/>
            <a:chExt cx="4958207" cy="2958769"/>
          </a:xfrm>
        </p:grpSpPr>
        <p:pic>
          <p:nvPicPr>
            <p:cNvPr id="15" name="Kép 7">
              <a:extLst>
                <a:ext uri="{FF2B5EF4-FFF2-40B4-BE49-F238E27FC236}">
                  <a16:creationId xmlns:a16="http://schemas.microsoft.com/office/drawing/2014/main" id="{4F517166-B24E-4220-AFD6-0491D73C18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435" r="15201" b="9607"/>
            <a:stretch/>
          </p:blipFill>
          <p:spPr>
            <a:xfrm>
              <a:off x="3454795" y="3914550"/>
              <a:ext cx="4153728" cy="251827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4EE062A-49EC-4FB3-8131-A6D831CC9D8F}"/>
                </a:ext>
              </a:extLst>
            </p:cNvPr>
            <p:cNvSpPr txBox="1"/>
            <p:nvPr/>
          </p:nvSpPr>
          <p:spPr>
            <a:xfrm>
              <a:off x="3170338" y="6565543"/>
              <a:ext cx="4775927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euroinflammation genes enrichment score 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885C748-985F-461C-A2D1-AECE97EC0BC1}"/>
                </a:ext>
              </a:extLst>
            </p:cNvPr>
            <p:cNvSpPr txBox="1"/>
            <p:nvPr/>
          </p:nvSpPr>
          <p:spPr>
            <a:xfrm>
              <a:off x="5475389" y="6350299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FC77D2D-B099-4031-94A4-73227FFC6E38}"/>
                </a:ext>
              </a:extLst>
            </p:cNvPr>
            <p:cNvSpPr txBox="1"/>
            <p:nvPr/>
          </p:nvSpPr>
          <p:spPr>
            <a:xfrm>
              <a:off x="3551447" y="6354670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36541C3-B108-493E-965E-0914D38560DA}"/>
                </a:ext>
              </a:extLst>
            </p:cNvPr>
            <p:cNvSpPr txBox="1"/>
            <p:nvPr/>
          </p:nvSpPr>
          <p:spPr>
            <a:xfrm>
              <a:off x="4473941" y="6362070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1F2B4D4-37A1-4636-BFEE-2BEB8048E60C}"/>
                </a:ext>
              </a:extLst>
            </p:cNvPr>
            <p:cNvSpPr txBox="1"/>
            <p:nvPr/>
          </p:nvSpPr>
          <p:spPr>
            <a:xfrm>
              <a:off x="6476839" y="6350298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CFF036A-EE9F-4D74-B1AF-9757D13ACD4A}"/>
                </a:ext>
              </a:extLst>
            </p:cNvPr>
            <p:cNvSpPr txBox="1"/>
            <p:nvPr/>
          </p:nvSpPr>
          <p:spPr>
            <a:xfrm>
              <a:off x="3280447" y="6150199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3EDFE58-9610-4DA8-B2D8-7B1D40BA5043}"/>
                </a:ext>
              </a:extLst>
            </p:cNvPr>
            <p:cNvSpPr txBox="1"/>
            <p:nvPr/>
          </p:nvSpPr>
          <p:spPr>
            <a:xfrm>
              <a:off x="3211330" y="5491116"/>
              <a:ext cx="32665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6636BE6-AC59-4E08-89B3-CF8C9CF8A21B}"/>
                </a:ext>
              </a:extLst>
            </p:cNvPr>
            <p:cNvSpPr txBox="1"/>
            <p:nvPr/>
          </p:nvSpPr>
          <p:spPr>
            <a:xfrm>
              <a:off x="3211330" y="4832033"/>
              <a:ext cx="32665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A6925F8-FBE5-4A2A-B598-3A07EBB300D8}"/>
                </a:ext>
              </a:extLst>
            </p:cNvPr>
            <p:cNvSpPr txBox="1"/>
            <p:nvPr/>
          </p:nvSpPr>
          <p:spPr>
            <a:xfrm>
              <a:off x="3211330" y="4157354"/>
              <a:ext cx="32665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B9B50B7-81B4-41D2-98F8-9878F6FC419E}"/>
                </a:ext>
              </a:extLst>
            </p:cNvPr>
            <p:cNvSpPr txBox="1"/>
            <p:nvPr/>
          </p:nvSpPr>
          <p:spPr>
            <a:xfrm rot="16200000">
              <a:off x="2232972" y="5278718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3B879B47-2A91-4EC1-B01D-3F3415BA7BA5}"/>
              </a:ext>
            </a:extLst>
          </p:cNvPr>
          <p:cNvSpPr/>
          <p:nvPr/>
        </p:nvSpPr>
        <p:spPr>
          <a:xfrm>
            <a:off x="3280864" y="1664560"/>
            <a:ext cx="238874" cy="130220"/>
          </a:xfrm>
          <a:prstGeom prst="rect">
            <a:avLst/>
          </a:prstGeom>
          <a:solidFill>
            <a:srgbClr val="FFC9C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>
              <a:solidFill>
                <a:srgbClr val="FFC9CA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028686C-C36E-41A8-855B-468683DC815F}"/>
              </a:ext>
            </a:extLst>
          </p:cNvPr>
          <p:cNvSpPr/>
          <p:nvPr/>
        </p:nvSpPr>
        <p:spPr>
          <a:xfrm>
            <a:off x="3280864" y="1891678"/>
            <a:ext cx="238874" cy="126686"/>
          </a:xfrm>
          <a:prstGeom prst="rect">
            <a:avLst/>
          </a:prstGeom>
          <a:solidFill>
            <a:srgbClr val="ADF5F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>
              <a:solidFill>
                <a:srgbClr val="FFC9CA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66B0D9-F22B-46BC-B578-81C5A20B838C}"/>
              </a:ext>
            </a:extLst>
          </p:cNvPr>
          <p:cNvSpPr txBox="1"/>
          <p:nvPr/>
        </p:nvSpPr>
        <p:spPr>
          <a:xfrm>
            <a:off x="3507252" y="1623798"/>
            <a:ext cx="246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lin2 pos astrocytes (aged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64C513-8FD7-4073-8AAE-266F93B32F2C}"/>
              </a:ext>
            </a:extLst>
          </p:cNvPr>
          <p:cNvSpPr txBox="1"/>
          <p:nvPr/>
        </p:nvSpPr>
        <p:spPr>
          <a:xfrm>
            <a:off x="3519738" y="1845859"/>
            <a:ext cx="246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lin2 neg astrocytes (aged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331E610-949A-4EA7-8CEE-E501D904ED0F}"/>
              </a:ext>
            </a:extLst>
          </p:cNvPr>
          <p:cNvSpPr txBox="1"/>
          <p:nvPr/>
        </p:nvSpPr>
        <p:spPr>
          <a:xfrm>
            <a:off x="1947909" y="1346011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E43B87C-BAD1-4D65-832A-46AE9582740F}"/>
              </a:ext>
            </a:extLst>
          </p:cNvPr>
          <p:cNvSpPr txBox="1"/>
          <p:nvPr/>
        </p:nvSpPr>
        <p:spPr>
          <a:xfrm>
            <a:off x="5778889" y="1368135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9F7C5BE-F667-4F71-900E-866467583759}"/>
              </a:ext>
            </a:extLst>
          </p:cNvPr>
          <p:cNvSpPr txBox="1"/>
          <p:nvPr/>
        </p:nvSpPr>
        <p:spPr>
          <a:xfrm>
            <a:off x="3631875" y="3781053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38257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huvana Plakkot</dc:creator>
  <cp:lastModifiedBy>Bhuvana Plakkot</cp:lastModifiedBy>
  <cp:revision>1</cp:revision>
  <dcterms:created xsi:type="dcterms:W3CDTF">2025-08-22T22:03:30Z</dcterms:created>
  <dcterms:modified xsi:type="dcterms:W3CDTF">2025-08-22T22:03:54Z</dcterms:modified>
</cp:coreProperties>
</file>